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henoy Mohan (R0A) Manchester University NHS FT" initials="SM(MUNF" lastIdx="4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68" autoAdjust="0"/>
    <p:restoredTop sz="94660"/>
  </p:normalViewPr>
  <p:slideViewPr>
    <p:cSldViewPr snapToGrid="0">
      <p:cViewPr varScale="1">
        <p:scale>
          <a:sx n="86" d="100"/>
          <a:sy n="86" d="100"/>
        </p:scale>
        <p:origin x="379" y="13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2/07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2/07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475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b="1" dirty="0">
                <a:solidFill>
                  <a:schemeClr val="bg1"/>
                </a:solidFill>
              </a:rPr>
              <a:t>Surgical management of Encapsulating Peritoneal </a:t>
            </a:r>
          </a:p>
          <a:p>
            <a:pPr marL="216000" algn="l"/>
            <a:r>
              <a:rPr lang="en-GB" b="1" dirty="0">
                <a:solidFill>
                  <a:schemeClr val="bg1"/>
                </a:solidFill>
              </a:rPr>
              <a:t>Sclerosis (EPS) in children: experience from an </a:t>
            </a:r>
          </a:p>
          <a:p>
            <a:pPr marL="216000" algn="l"/>
            <a:r>
              <a:rPr lang="en-GB" b="1" dirty="0">
                <a:solidFill>
                  <a:schemeClr val="bg1"/>
                </a:solidFill>
              </a:rPr>
              <a:t>international referral centre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dirty="0"/>
              <a:t>Highlight the clinical challenges surrounding the surgical management of EPS in children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Sharma et al. 202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Specialist surgical technique, including entire small bowel </a:t>
            </a:r>
            <a:r>
              <a:rPr lang="en-GB" dirty="0" err="1">
                <a:solidFill>
                  <a:schemeClr val="bg1"/>
                </a:solidFill>
              </a:rPr>
              <a:t>enterolysis</a:t>
            </a:r>
            <a:r>
              <a:rPr lang="en-GB" dirty="0">
                <a:solidFill>
                  <a:schemeClr val="bg1"/>
                </a:solidFill>
              </a:rPr>
              <a:t>, demonstrates favourable outcomes in paediatric EPS and provides a bridge to subsequent transplantation.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A1F3BD10-B762-3A42-98C2-431F134552E6}"/>
              </a:ext>
            </a:extLst>
          </p:cNvPr>
          <p:cNvGrpSpPr/>
          <p:nvPr/>
        </p:nvGrpSpPr>
        <p:grpSpPr>
          <a:xfrm>
            <a:off x="981353" y="2819707"/>
            <a:ext cx="605709" cy="1167552"/>
            <a:chOff x="4935032" y="2546389"/>
            <a:chExt cx="831040" cy="1719662"/>
          </a:xfrm>
        </p:grpSpPr>
        <p:sp>
          <p:nvSpPr>
            <p:cNvPr id="14" name="Freeform: Shape 46">
              <a:extLst>
                <a:ext uri="{FF2B5EF4-FFF2-40B4-BE49-F238E27FC236}">
                  <a16:creationId xmlns:a16="http://schemas.microsoft.com/office/drawing/2014/main" id="{BABA3553-5DEC-304B-9E75-165F62E87FEC}"/>
                </a:ext>
              </a:extLst>
            </p:cNvPr>
            <p:cNvSpPr/>
            <p:nvPr/>
          </p:nvSpPr>
          <p:spPr>
            <a:xfrm>
              <a:off x="4935032" y="2919538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16" name="Freeform: Shape 46">
              <a:extLst>
                <a:ext uri="{FF2B5EF4-FFF2-40B4-BE49-F238E27FC236}">
                  <a16:creationId xmlns:a16="http://schemas.microsoft.com/office/drawing/2014/main" id="{25F05EAD-899D-9147-8C52-918021AD3A93}"/>
                </a:ext>
              </a:extLst>
            </p:cNvPr>
            <p:cNvSpPr/>
            <p:nvPr/>
          </p:nvSpPr>
          <p:spPr>
            <a:xfrm>
              <a:off x="5252788" y="3090929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17" name="Freeform: Shape 46">
              <a:extLst>
                <a:ext uri="{FF2B5EF4-FFF2-40B4-BE49-F238E27FC236}">
                  <a16:creationId xmlns:a16="http://schemas.microsoft.com/office/drawing/2014/main" id="{017AF9E3-B54C-774E-A519-DAF88C3889A1}"/>
                </a:ext>
              </a:extLst>
            </p:cNvPr>
            <p:cNvSpPr/>
            <p:nvPr/>
          </p:nvSpPr>
          <p:spPr>
            <a:xfrm>
              <a:off x="5160138" y="2546389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15" name="Freeform: Shape 46">
              <a:extLst>
                <a:ext uri="{FF2B5EF4-FFF2-40B4-BE49-F238E27FC236}">
                  <a16:creationId xmlns:a16="http://schemas.microsoft.com/office/drawing/2014/main" id="{EE2BC9EC-B56A-1F4B-A9D8-FADD519C1D3F}"/>
                </a:ext>
              </a:extLst>
            </p:cNvPr>
            <p:cNvSpPr/>
            <p:nvPr/>
          </p:nvSpPr>
          <p:spPr>
            <a:xfrm>
              <a:off x="5067488" y="3216153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259E32FE-2880-8547-995E-98635CEA7DC0}"/>
              </a:ext>
            </a:extLst>
          </p:cNvPr>
          <p:cNvGrpSpPr/>
          <p:nvPr/>
        </p:nvGrpSpPr>
        <p:grpSpPr>
          <a:xfrm>
            <a:off x="377006" y="4202625"/>
            <a:ext cx="2058763" cy="1346911"/>
            <a:chOff x="690894" y="4115191"/>
            <a:chExt cx="2058763" cy="1346911"/>
          </a:xfrm>
        </p:grpSpPr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4FC5AECF-2795-6641-BBC4-F03CDD066886}"/>
                </a:ext>
              </a:extLst>
            </p:cNvPr>
            <p:cNvSpPr/>
            <p:nvPr/>
          </p:nvSpPr>
          <p:spPr>
            <a:xfrm>
              <a:off x="690894" y="4115191"/>
              <a:ext cx="1735313" cy="804718"/>
            </a:xfrm>
            <a:prstGeom prst="rect">
              <a:avLst/>
            </a:prstGeom>
            <a:noFill/>
            <a:ln w="41275">
              <a:solidFill>
                <a:srgbClr val="296D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solidFill>
                    <a:srgbClr val="296DC0"/>
                  </a:solidFill>
                </a:rPr>
                <a:t>4 patients referred across Europe</a:t>
              </a:r>
            </a:p>
          </p:txBody>
        </p:sp>
        <p:pic>
          <p:nvPicPr>
            <p:cNvPr id="1026" name="Picture 2" descr="https://documents.app.lucidchart.com/documents/5cadd718-db4c-4fb0-a0a0-5ac310c18365/pages/0_0?a=133&amp;x=376&amp;y=183&amp;w=167&amp;h=185&amp;store=1&amp;accept=image%2F*&amp;auth=LCA%20293d6b2513306ed441cbcbebc38314d2b4aa360a-ts%3D1608565405">
              <a:extLst>
                <a:ext uri="{FF2B5EF4-FFF2-40B4-BE49-F238E27FC236}">
                  <a16:creationId xmlns:a16="http://schemas.microsoft.com/office/drawing/2014/main" id="{51981BC8-DA45-2842-AEF3-84C17539914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89" t="13624" r="12766" b="15835"/>
            <a:stretch/>
          </p:blipFill>
          <p:spPr bwMode="auto">
            <a:xfrm>
              <a:off x="2051675" y="4691063"/>
              <a:ext cx="697982" cy="77103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91D68B2E-6F7B-F548-B86A-4CA94E34A629}"/>
              </a:ext>
            </a:extLst>
          </p:cNvPr>
          <p:cNvSpPr txBox="1"/>
          <p:nvPr/>
        </p:nvSpPr>
        <p:spPr>
          <a:xfrm>
            <a:off x="180183" y="2094233"/>
            <a:ext cx="212896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Retrospective case note review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8D1FBED3-213C-4B48-82A5-83ADB15C03E5}"/>
              </a:ext>
            </a:extLst>
          </p:cNvPr>
          <p:cNvSpPr/>
          <p:nvPr/>
        </p:nvSpPr>
        <p:spPr>
          <a:xfrm>
            <a:off x="2833147" y="2847143"/>
            <a:ext cx="1735313" cy="928184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Median duration of PD: 78 months </a:t>
            </a:r>
          </a:p>
        </p:txBody>
      </p:sp>
      <p:pic>
        <p:nvPicPr>
          <p:cNvPr id="1036" name="Picture 12" descr="https://documents.app.lucidchart.com/documents/5cadd718-db4c-4fb0-a0a0-5ac310c18365/pages/0_0?a=151&amp;x=52&amp;y=-128&amp;w=185&amp;h=185&amp;store=1&amp;accept=image%2F*&amp;auth=LCA%204367696d69c457fbc5c4a9e331e2ddbac183877c-ts%3D1608565405">
            <a:extLst>
              <a:ext uri="{FF2B5EF4-FFF2-40B4-BE49-F238E27FC236}">
                <a16:creationId xmlns:a16="http://schemas.microsoft.com/office/drawing/2014/main" id="{CA982187-BB4E-8444-A89C-8DA24B81C3E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67" t="22486" r="23208" b="23193"/>
          <a:stretch/>
        </p:blipFill>
        <p:spPr bwMode="auto">
          <a:xfrm>
            <a:off x="4273615" y="3568290"/>
            <a:ext cx="425279" cy="428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8" name="Rectangle 47">
            <a:extLst>
              <a:ext uri="{FF2B5EF4-FFF2-40B4-BE49-F238E27FC236}">
                <a16:creationId xmlns:a16="http://schemas.microsoft.com/office/drawing/2014/main" id="{13E7445B-D694-6F46-8B9B-B43BBBC5E81F}"/>
              </a:ext>
            </a:extLst>
          </p:cNvPr>
          <p:cNvSpPr/>
          <p:nvPr/>
        </p:nvSpPr>
        <p:spPr>
          <a:xfrm>
            <a:off x="2833147" y="4164104"/>
            <a:ext cx="1735313" cy="928184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Symptoms post change of dialysis mode</a:t>
            </a:r>
          </a:p>
        </p:txBody>
      </p:sp>
      <p:pic>
        <p:nvPicPr>
          <p:cNvPr id="1040" name="Picture 16" descr="https://documents.app.lucidchart.com/documents/5cadd718-db4c-4fb0-a0a0-5ac310c18365/pages/0_0?a=164&amp;x=332&amp;y=-148&amp;w=185&amp;h=185&amp;store=1&amp;accept=image%2F*&amp;auth=LCA%207a334770f0053a35096b1d3695d47690d6997769-ts%3D1608565405">
            <a:extLst>
              <a:ext uri="{FF2B5EF4-FFF2-40B4-BE49-F238E27FC236}">
                <a16:creationId xmlns:a16="http://schemas.microsoft.com/office/drawing/2014/main" id="{B45EE196-C045-B948-BC42-BD2963CA4B5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31" t="16111" r="19051" b="16758"/>
          <a:stretch/>
        </p:blipFill>
        <p:spPr bwMode="auto">
          <a:xfrm>
            <a:off x="4325885" y="4901494"/>
            <a:ext cx="400386" cy="4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0" name="Rectangle 49">
            <a:extLst>
              <a:ext uri="{FF2B5EF4-FFF2-40B4-BE49-F238E27FC236}">
                <a16:creationId xmlns:a16="http://schemas.microsoft.com/office/drawing/2014/main" id="{01B64122-1907-FB42-A8A8-1F688B47C75D}"/>
              </a:ext>
            </a:extLst>
          </p:cNvPr>
          <p:cNvSpPr/>
          <p:nvPr/>
        </p:nvSpPr>
        <p:spPr>
          <a:xfrm>
            <a:off x="4789369" y="2850861"/>
            <a:ext cx="1735313" cy="928184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Malnourished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F8C05BBA-3C86-6C44-8A94-477D7A27F367}"/>
              </a:ext>
            </a:extLst>
          </p:cNvPr>
          <p:cNvSpPr/>
          <p:nvPr/>
        </p:nvSpPr>
        <p:spPr>
          <a:xfrm>
            <a:off x="6745590" y="2831613"/>
            <a:ext cx="1735313" cy="928184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Parenteral nutrition to optimise 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FE8D5FD9-8CC3-5B42-9C36-CE96AC84C422}"/>
              </a:ext>
            </a:extLst>
          </p:cNvPr>
          <p:cNvSpPr/>
          <p:nvPr/>
        </p:nvSpPr>
        <p:spPr>
          <a:xfrm>
            <a:off x="4789368" y="4148445"/>
            <a:ext cx="1735313" cy="928184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Episodes of recurrent peritonitis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15AE571D-7D5D-C149-A0D5-680B91D5E49D}"/>
              </a:ext>
            </a:extLst>
          </p:cNvPr>
          <p:cNvSpPr/>
          <p:nvPr/>
        </p:nvSpPr>
        <p:spPr>
          <a:xfrm>
            <a:off x="6745590" y="4136631"/>
            <a:ext cx="1735313" cy="928184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Multiple specialist surgeries</a:t>
            </a:r>
          </a:p>
        </p:txBody>
      </p:sp>
      <p:pic>
        <p:nvPicPr>
          <p:cNvPr id="1042" name="Picture 18" descr="https://documents.app.lucidchart.com/documents/5cadd718-db4c-4fb0-a0a0-5ac310c18365/pages/0_0?a=172&amp;x=52&amp;y=-108&amp;w=185&amp;h=185&amp;store=1&amp;accept=image%2F*&amp;auth=LCA%20f4bfab23022018cf89981cf2f826ce6678f22d50-ts%3D1608565405">
            <a:extLst>
              <a:ext uri="{FF2B5EF4-FFF2-40B4-BE49-F238E27FC236}">
                <a16:creationId xmlns:a16="http://schemas.microsoft.com/office/drawing/2014/main" id="{2F16D771-855F-A849-AA88-A9F5A7670C4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55" t="16111" r="19051" b="16246"/>
          <a:stretch/>
        </p:blipFill>
        <p:spPr bwMode="auto">
          <a:xfrm>
            <a:off x="8299412" y="4905567"/>
            <a:ext cx="415722" cy="4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4" name="Picture 20" descr="https://documents.app.lucidchart.com/documents/5cadd718-db4c-4fb0-a0a0-5ac310c18365/pages/0_0?a=186&amp;x=92&amp;y=-156&amp;w=185&amp;h=185&amp;store=1&amp;accept=image%2F*&amp;auth=LCA%2044bfcce3e86fdd0de12d1433fb02412f520d94e7-ts%3D1608565405">
            <a:extLst>
              <a:ext uri="{FF2B5EF4-FFF2-40B4-BE49-F238E27FC236}">
                <a16:creationId xmlns:a16="http://schemas.microsoft.com/office/drawing/2014/main" id="{81E6E561-F4C8-6347-A1EF-ED929EF6F46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73" t="14457" r="14006" b="12022"/>
          <a:stretch/>
        </p:blipFill>
        <p:spPr bwMode="auto">
          <a:xfrm>
            <a:off x="6343191" y="4901494"/>
            <a:ext cx="423769" cy="4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6" name="Picture 22" descr="https://documents.app.lucidchart.com/documents/5cadd718-db4c-4fb0-a0a0-5ac310c18365/pages/0_0?a=194&amp;x=422&amp;y=-188&amp;w=185&amp;h=185&amp;store=1&amp;accept=image%2F*&amp;auth=LCA%203028e14a1f50f83767271faadd293656cb91d05d-ts%3D1608565405">
            <a:extLst>
              <a:ext uri="{FF2B5EF4-FFF2-40B4-BE49-F238E27FC236}">
                <a16:creationId xmlns:a16="http://schemas.microsoft.com/office/drawing/2014/main" id="{73F149B8-266D-1842-98C7-34CE2A2D6B5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24" t="19001" r="27058" b="18376"/>
          <a:stretch/>
        </p:blipFill>
        <p:spPr bwMode="auto">
          <a:xfrm>
            <a:off x="6296411" y="3568290"/>
            <a:ext cx="295200" cy="4327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718F083A-CE1D-884D-B8A2-2786052035C7}"/>
              </a:ext>
            </a:extLst>
          </p:cNvPr>
          <p:cNvSpPr txBox="1"/>
          <p:nvPr/>
        </p:nvSpPr>
        <p:spPr>
          <a:xfrm>
            <a:off x="3477616" y="2286515"/>
            <a:ext cx="24053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65AA00"/>
                </a:solidFill>
              </a:rPr>
              <a:t>Clinical  presentation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53F4C8A2-639B-A34B-B70A-8DF74088F341}"/>
              </a:ext>
            </a:extLst>
          </p:cNvPr>
          <p:cNvSpPr/>
          <p:nvPr/>
        </p:nvSpPr>
        <p:spPr>
          <a:xfrm>
            <a:off x="8981136" y="2887690"/>
            <a:ext cx="2806752" cy="2204598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rgbClr val="00437A"/>
                </a:solidFill>
              </a:rPr>
              <a:t>100% survival despite high risk of morbidity (sepsis/fistula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rgbClr val="00437A"/>
                </a:solidFill>
              </a:rPr>
              <a:t>All re-established on enteral nutri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rgbClr val="00437A"/>
                </a:solidFill>
              </a:rPr>
              <a:t>2/4 patients transplanted, 2/4 remain on haemodialysis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89F163F-9550-364C-9282-A012DA0296FE}"/>
              </a:ext>
            </a:extLst>
          </p:cNvPr>
          <p:cNvSpPr txBox="1"/>
          <p:nvPr/>
        </p:nvSpPr>
        <p:spPr>
          <a:xfrm>
            <a:off x="9496969" y="2283328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Outcomes</a:t>
            </a:r>
          </a:p>
        </p:txBody>
      </p:sp>
      <p:pic>
        <p:nvPicPr>
          <p:cNvPr id="6" name="Picture 2" descr="https://documents.app.lucidchart.com/documents/cf917a97-b294-40c5-9265-1c1233fb8310/pages/0_0?a=2442&amp;x=252&amp;y=1012&amp;w=185&amp;h=185&amp;store=1&amp;accept=image%2F*&amp;auth=LCA%203a04c2e125d38bbec99cfb4a8ac3dee6370b5a77-ts%3D1608724308">
            <a:extLst>
              <a:ext uri="{FF2B5EF4-FFF2-40B4-BE49-F238E27FC236}">
                <a16:creationId xmlns:a16="http://schemas.microsoft.com/office/drawing/2014/main" id="{262245AD-D368-124F-B494-3A08E3C1E74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69" t="14496" r="16051" b="11726"/>
          <a:stretch/>
        </p:blipFill>
        <p:spPr bwMode="auto">
          <a:xfrm>
            <a:off x="8313571" y="3568290"/>
            <a:ext cx="401563" cy="4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DDDE2389-09C4-4343-8014-CB1E6DA708B3}"/>
              </a:ext>
            </a:extLst>
          </p:cNvPr>
          <p:cNvSpPr txBox="1"/>
          <p:nvPr/>
        </p:nvSpPr>
        <p:spPr>
          <a:xfrm>
            <a:off x="6591344" y="2286515"/>
            <a:ext cx="19713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65AA00"/>
                </a:solidFill>
              </a:rPr>
              <a:t>Intervention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64</TotalTime>
  <Words>132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5</cp:revision>
  <dcterms:created xsi:type="dcterms:W3CDTF">2019-06-13T12:30:18Z</dcterms:created>
  <dcterms:modified xsi:type="dcterms:W3CDTF">2021-07-22T21:28:46Z</dcterms:modified>
</cp:coreProperties>
</file>